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75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DE98CA0-3E35-5FBE-4E79-DDE1C44484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8B44612-3CD0-96B8-3A18-439D1CDE19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06670BA-FFD2-93CE-C70E-15240226B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92F23A-4B71-81BE-FEBA-92D8ABB7E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8984421-AD29-413F-E8C8-8351BE803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6876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6CB10F-FE54-03AA-1619-E92557EC24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0989D18-1228-72AC-4002-3C81867F96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7835016-9AE0-E9F0-FA0F-E0797D97C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A6685DE-569A-8DDD-E750-1D8C4774A0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A3975E3-76F2-52BD-F5D6-F53170F18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1950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E73CECBA-8B0F-AE17-511B-B190FBDE84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6C7F86E-347A-73BF-1017-D9870A30E2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C57DBCF-71E2-2E05-23E0-11B893F37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BFD70D3-F8D9-E486-DF51-97FE0A8998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A9AF2D4-257A-8036-1C0E-B4D46AFB0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1540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8456A78-4065-61C0-4350-90783EEBCC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00354D6-7999-9037-4270-3C79468616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A982F53-1C27-EA95-D663-91ED81CB5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C1EAE49-EB1F-EF5D-3888-5A9F74CFB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D07DD0E-60FD-07BD-CA34-A28191D7B8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1166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130F0A0-4170-2190-4C3F-AE770715B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EBB018A-A9C1-883B-9E8B-B373D4F532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5498DA8-AC6A-1916-7126-11FCE3CAD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CBBB26A-56C7-5E46-0F89-429A3F83B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BADD765-7408-B39E-4424-A3E65C8662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3791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56C948-795B-96E5-B9B5-3195212BD6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DE27859-01F5-088F-5C98-57BF4F975D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5283560-6F84-E0AC-20ED-E0797A6B25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6DC91CF-3BDC-BBEA-FFA3-75BBDA296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204E0E3-D69D-E60B-0B9C-23CEAF1F2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D9B4E55-1FD6-7A8A-D8D7-49DAA6C5E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3710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A2B27E-DC11-982C-C9B2-DBE75DE7C8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B05BF2E-4D12-0D18-FD53-8AD6CE1805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D75DBCF-BAA7-4A1A-4971-567B994093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55B0AF8-B9A3-5739-E293-98CFBD1B4F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FBFE827-152B-14D1-3589-FB4617D114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E30ECD9-DF6E-37D7-9C1E-126C498DB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B29000B2-AC05-3434-37C3-CC424C9B6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C4824A51-6881-8884-5E07-E0EBC349E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5261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DAA71E-4E86-3314-B500-E6E9E22FB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2A771778-FFDB-686D-371E-D08F015D5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E691CBF4-1C53-FCF4-8D65-B2AC3FE8F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6E643AD8-45B0-A501-186B-E586AB7C2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7103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8F7CCB7-0D41-1FC8-4380-6027BE602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63D83646-8FF9-706A-148E-369BEFEF2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E7515D23-8FD0-7233-52C9-BC25367833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9990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3E57098-22A0-7334-65C2-E5EBD0FA33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2141EB0-35B3-B5D3-A47E-376095665C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94AE4FC-11AC-BD51-D4BB-9C9550A817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6DAE134-1AAC-E1D1-AE46-97D94D521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CC4C665-E12E-0203-23BC-3FF2127FB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B6F1413-C400-ECA4-513C-C0D9E31AB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46905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719E3E-5CCC-B7FC-7FE0-2FB0B12034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5FE7C2A-A2CE-CB38-C36E-251B87CBAE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EDFF4B1-8D80-89DE-F14E-797590130A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716BA54-4B18-126E-F224-54427B595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203EF0F-E04A-DEF2-BEF5-FD44BEF5D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1029D7E-2312-3199-80DE-E93E57FB52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2930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4CE31971-5986-88BE-437C-FEAACFA339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78564C5-6486-6F74-DB66-C6E0BF3F10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1B81180-B909-5671-BC77-58D9CB2A932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F7C3D5-9A49-4B7E-8F75-93FC9E8F0853}" type="datetimeFigureOut">
              <a:rPr lang="ko-KR" altLang="en-US" smtClean="0"/>
              <a:t>2026-05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8641CA3-8FA9-5D4F-7063-6E80C0D77F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A7235C2-43F5-AC53-8C25-971C33D668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1A4B4-55A7-47E3-9BB6-EDBFE86786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0367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jpg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B4084B13-F814-F27D-4D6D-417ACBAF2D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127" y="0"/>
            <a:ext cx="2982298" cy="4100659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BC51D6D1-8950-CD18-77B3-4EF22F832F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4217" y="3262039"/>
            <a:ext cx="1447315" cy="140072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359C815-EF4C-1F77-C5A3-AB81FF64179B}"/>
              </a:ext>
            </a:extLst>
          </p:cNvPr>
          <p:cNvSpPr txBox="1"/>
          <p:nvPr/>
        </p:nvSpPr>
        <p:spPr>
          <a:xfrm>
            <a:off x="377034" y="5627397"/>
            <a:ext cx="1171575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b="1" dirty="0"/>
              <a:t>Supplementary Data</a:t>
            </a:r>
            <a:r>
              <a:rPr lang="ko-KR" altLang="en-US" b="1" dirty="0"/>
              <a:t> </a:t>
            </a:r>
            <a:r>
              <a:rPr lang="en-US" altLang="ko-KR" b="1" dirty="0"/>
              <a:t>6. Uncropped Western blot images.</a:t>
            </a:r>
            <a:br>
              <a:rPr lang="en-US" altLang="ko-KR" dirty="0"/>
            </a:br>
            <a:r>
              <a:rPr lang="en-US" altLang="ko-KR" dirty="0"/>
              <a:t>Uncropped Western blot images corresponding to Figure 1C. The full-length blots are shown with molecular weight markers and lane annotations. These images represent the original, unprocessed data prior to cropping for presentation in the main figures.</a:t>
            </a:r>
            <a:endParaRPr lang="ko-KR" alt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F548187-0DCB-3E1F-0DD1-EB15E4AAD267}"/>
              </a:ext>
            </a:extLst>
          </p:cNvPr>
          <p:cNvSpPr txBox="1"/>
          <p:nvPr/>
        </p:nvSpPr>
        <p:spPr>
          <a:xfrm>
            <a:off x="628112" y="154584"/>
            <a:ext cx="309565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Anti-GAPDH</a:t>
            </a:r>
          </a:p>
          <a:p>
            <a:r>
              <a:rPr lang="en-US" altLang="ko-KR" dirty="0" err="1"/>
              <a:t>Mybiosource</a:t>
            </a:r>
            <a:r>
              <a:rPr lang="en-US" altLang="ko-KR" dirty="0"/>
              <a:t>, MBS9373474 </a:t>
            </a:r>
            <a:endParaRPr lang="ko-KR" altLang="en-US" dirty="0"/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626B89DD-6109-F3FC-812F-970779A9AA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4847" y="0"/>
            <a:ext cx="2982298" cy="4100659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AE16FB7B-4EC0-A90B-EF07-206CD11F880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4262" y="3262039"/>
            <a:ext cx="1243468" cy="1418194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47A8D0F0-196A-01D9-DCA0-D98002E5F1E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7709" y="0"/>
            <a:ext cx="2982298" cy="4100659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7F1A9E76-7C0E-0A0F-FA61-3C2E345D306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6698" y="3262039"/>
            <a:ext cx="1211434" cy="142110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01B5598-DD63-4555-8CC9-881CCBAAB1E5}"/>
              </a:ext>
            </a:extLst>
          </p:cNvPr>
          <p:cNvSpPr txBox="1"/>
          <p:nvPr/>
        </p:nvSpPr>
        <p:spPr>
          <a:xfrm>
            <a:off x="4820422" y="154583"/>
            <a:ext cx="22897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Anti-TET-8</a:t>
            </a:r>
          </a:p>
          <a:p>
            <a:r>
              <a:rPr lang="en-US" altLang="ko-KR" dirty="0" err="1"/>
              <a:t>PhytoAb</a:t>
            </a:r>
            <a:r>
              <a:rPr lang="en-US" altLang="ko-KR" dirty="0"/>
              <a:t>, PHY1490A</a:t>
            </a:r>
            <a:endParaRPr lang="ko-KR" alt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0FF2CBC-E47B-F048-6EAC-CACC50CAAF7D}"/>
              </a:ext>
            </a:extLst>
          </p:cNvPr>
          <p:cNvSpPr txBox="1"/>
          <p:nvPr/>
        </p:nvSpPr>
        <p:spPr>
          <a:xfrm>
            <a:off x="7710574" y="154583"/>
            <a:ext cx="37095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Anti-PEN1</a:t>
            </a:r>
          </a:p>
          <a:p>
            <a:r>
              <a:rPr lang="en-US" altLang="ko-KR" dirty="0" err="1"/>
              <a:t>Cusabio</a:t>
            </a:r>
            <a:r>
              <a:rPr lang="en-US" altLang="ko-KR" dirty="0"/>
              <a:t>, CSB-PA875527XA01DOA</a:t>
            </a:r>
            <a:endParaRPr lang="ko-KR" alt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602F761-83A1-1BBB-D87C-54B5165652E0}"/>
              </a:ext>
            </a:extLst>
          </p:cNvPr>
          <p:cNvSpPr txBox="1"/>
          <p:nvPr/>
        </p:nvSpPr>
        <p:spPr>
          <a:xfrm>
            <a:off x="4511261" y="3177028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A72B4FF-14F3-2E8A-53C5-9AAB1996F23A}"/>
              </a:ext>
            </a:extLst>
          </p:cNvPr>
          <p:cNvSpPr txBox="1"/>
          <p:nvPr/>
        </p:nvSpPr>
        <p:spPr>
          <a:xfrm>
            <a:off x="4511261" y="3327840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3770F2C-D85D-DECC-0A5E-AAC70464B381}"/>
              </a:ext>
            </a:extLst>
          </p:cNvPr>
          <p:cNvSpPr txBox="1"/>
          <p:nvPr/>
        </p:nvSpPr>
        <p:spPr>
          <a:xfrm>
            <a:off x="4511261" y="3455793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0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63565F5-EAFD-41EE-37DE-2D7FDC0D1DC7}"/>
              </a:ext>
            </a:extLst>
          </p:cNvPr>
          <p:cNvSpPr txBox="1"/>
          <p:nvPr/>
        </p:nvSpPr>
        <p:spPr>
          <a:xfrm>
            <a:off x="4581793" y="3576126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7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F0F2850-B6C5-363D-A56A-031E4EA4EB24}"/>
              </a:ext>
            </a:extLst>
          </p:cNvPr>
          <p:cNvSpPr txBox="1"/>
          <p:nvPr/>
        </p:nvSpPr>
        <p:spPr>
          <a:xfrm>
            <a:off x="4581793" y="3742179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20A3E4D-976C-17C4-78FD-D8ECCBA5FBEC}"/>
              </a:ext>
            </a:extLst>
          </p:cNvPr>
          <p:cNvSpPr txBox="1"/>
          <p:nvPr/>
        </p:nvSpPr>
        <p:spPr>
          <a:xfrm>
            <a:off x="4581793" y="3885372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37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3592A01-DB90-AC95-D6C6-75E0F199975B}"/>
              </a:ext>
            </a:extLst>
          </p:cNvPr>
          <p:cNvSpPr txBox="1"/>
          <p:nvPr/>
        </p:nvSpPr>
        <p:spPr>
          <a:xfrm>
            <a:off x="4581793" y="4041265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71E2702-A918-B5BA-1447-49D8D56048B7}"/>
              </a:ext>
            </a:extLst>
          </p:cNvPr>
          <p:cNvSpPr txBox="1"/>
          <p:nvPr/>
        </p:nvSpPr>
        <p:spPr>
          <a:xfrm>
            <a:off x="4581793" y="4148898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F13113E-2B6B-5654-0545-7C7CB2F0E893}"/>
              </a:ext>
            </a:extLst>
          </p:cNvPr>
          <p:cNvSpPr txBox="1"/>
          <p:nvPr/>
        </p:nvSpPr>
        <p:spPr>
          <a:xfrm>
            <a:off x="4581793" y="4312408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1678E31-3E9B-6699-F6A1-D4B1474973C4}"/>
              </a:ext>
            </a:extLst>
          </p:cNvPr>
          <p:cNvSpPr txBox="1"/>
          <p:nvPr/>
        </p:nvSpPr>
        <p:spPr>
          <a:xfrm>
            <a:off x="698781" y="3165583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B75665C-F66B-852D-B42F-5EE4877CF7F4}"/>
              </a:ext>
            </a:extLst>
          </p:cNvPr>
          <p:cNvSpPr txBox="1"/>
          <p:nvPr/>
        </p:nvSpPr>
        <p:spPr>
          <a:xfrm>
            <a:off x="698781" y="3316395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830968F-D20A-F986-E87E-BA95669A2777}"/>
              </a:ext>
            </a:extLst>
          </p:cNvPr>
          <p:cNvSpPr txBox="1"/>
          <p:nvPr/>
        </p:nvSpPr>
        <p:spPr>
          <a:xfrm>
            <a:off x="698781" y="3444348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0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168DE57-85D9-CDA4-643A-C88276891850}"/>
              </a:ext>
            </a:extLst>
          </p:cNvPr>
          <p:cNvSpPr txBox="1"/>
          <p:nvPr/>
        </p:nvSpPr>
        <p:spPr>
          <a:xfrm>
            <a:off x="769313" y="3564681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7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03A661A-38D2-A79C-BD9B-A1A22BA59184}"/>
              </a:ext>
            </a:extLst>
          </p:cNvPr>
          <p:cNvSpPr txBox="1"/>
          <p:nvPr/>
        </p:nvSpPr>
        <p:spPr>
          <a:xfrm>
            <a:off x="769313" y="3730734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E1ADE54-AB89-EE85-571B-E05B108C1A05}"/>
              </a:ext>
            </a:extLst>
          </p:cNvPr>
          <p:cNvSpPr txBox="1"/>
          <p:nvPr/>
        </p:nvSpPr>
        <p:spPr>
          <a:xfrm>
            <a:off x="769313" y="3873927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37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77F14E3-34A8-E78E-1E8A-39E85F3B6BD3}"/>
              </a:ext>
            </a:extLst>
          </p:cNvPr>
          <p:cNvSpPr txBox="1"/>
          <p:nvPr/>
        </p:nvSpPr>
        <p:spPr>
          <a:xfrm>
            <a:off x="769313" y="4029820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581891D-8154-0122-D6BD-2161F8437DB6}"/>
              </a:ext>
            </a:extLst>
          </p:cNvPr>
          <p:cNvSpPr txBox="1"/>
          <p:nvPr/>
        </p:nvSpPr>
        <p:spPr>
          <a:xfrm>
            <a:off x="769313" y="4137453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000CDD6-0EAA-32DD-C1E4-8D31B6011B7F}"/>
              </a:ext>
            </a:extLst>
          </p:cNvPr>
          <p:cNvSpPr txBox="1"/>
          <p:nvPr/>
        </p:nvSpPr>
        <p:spPr>
          <a:xfrm>
            <a:off x="769313" y="4300963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5AD3357-9745-3EC6-0395-F2BC9DDF290C}"/>
              </a:ext>
            </a:extLst>
          </p:cNvPr>
          <p:cNvSpPr txBox="1"/>
          <p:nvPr/>
        </p:nvSpPr>
        <p:spPr>
          <a:xfrm>
            <a:off x="8169647" y="3204524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648812F-96F4-198A-B25E-9F8B7F7A533F}"/>
              </a:ext>
            </a:extLst>
          </p:cNvPr>
          <p:cNvSpPr txBox="1"/>
          <p:nvPr/>
        </p:nvSpPr>
        <p:spPr>
          <a:xfrm>
            <a:off x="8169647" y="3355336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07096B6-EC08-2F2B-D180-F67A150D6F24}"/>
              </a:ext>
            </a:extLst>
          </p:cNvPr>
          <p:cNvSpPr txBox="1"/>
          <p:nvPr/>
        </p:nvSpPr>
        <p:spPr>
          <a:xfrm>
            <a:off x="8169647" y="3483289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0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35038BD-E2E5-2F11-ABEA-5AC67C6044DD}"/>
              </a:ext>
            </a:extLst>
          </p:cNvPr>
          <p:cNvSpPr txBox="1"/>
          <p:nvPr/>
        </p:nvSpPr>
        <p:spPr>
          <a:xfrm>
            <a:off x="8240179" y="3603622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7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212CD63-C3ED-6AB8-C677-D218F63A1351}"/>
              </a:ext>
            </a:extLst>
          </p:cNvPr>
          <p:cNvSpPr txBox="1"/>
          <p:nvPr/>
        </p:nvSpPr>
        <p:spPr>
          <a:xfrm>
            <a:off x="8240179" y="3769675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5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D808AFB-11D4-60C2-48D4-5E53B55977C9}"/>
              </a:ext>
            </a:extLst>
          </p:cNvPr>
          <p:cNvSpPr txBox="1"/>
          <p:nvPr/>
        </p:nvSpPr>
        <p:spPr>
          <a:xfrm>
            <a:off x="8240179" y="3912868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37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A37B279-B259-9116-6CD1-8A289F46BDE8}"/>
              </a:ext>
            </a:extLst>
          </p:cNvPr>
          <p:cNvSpPr txBox="1"/>
          <p:nvPr/>
        </p:nvSpPr>
        <p:spPr>
          <a:xfrm>
            <a:off x="8240179" y="4068761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DC17B3F-527E-E42A-2D20-8374A9C96431}"/>
              </a:ext>
            </a:extLst>
          </p:cNvPr>
          <p:cNvSpPr txBox="1"/>
          <p:nvPr/>
        </p:nvSpPr>
        <p:spPr>
          <a:xfrm>
            <a:off x="8240179" y="4176394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20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DB2C39C-A752-216C-AE80-6E33BD7EF99A}"/>
              </a:ext>
            </a:extLst>
          </p:cNvPr>
          <p:cNvSpPr txBox="1"/>
          <p:nvPr/>
        </p:nvSpPr>
        <p:spPr>
          <a:xfrm>
            <a:off x="8240179" y="4339904"/>
            <a:ext cx="5934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/>
              <a:t>15 </a:t>
            </a:r>
            <a:r>
              <a:rPr lang="en-US" altLang="ko-KR" sz="1000" dirty="0" err="1"/>
              <a:t>kDa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960279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16</Words>
  <Application>Microsoft Office PowerPoint</Application>
  <PresentationFormat>와이드스크린</PresentationFormat>
  <Paragraphs>3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ehyun Ha</dc:creator>
  <cp:lastModifiedBy>Daehyun Ha</cp:lastModifiedBy>
  <cp:revision>4</cp:revision>
  <dcterms:created xsi:type="dcterms:W3CDTF">2026-05-02T04:41:53Z</dcterms:created>
  <dcterms:modified xsi:type="dcterms:W3CDTF">2026-05-07T05:46:37Z</dcterms:modified>
</cp:coreProperties>
</file>